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1411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00"/>
    <a:srgbClr val="60A5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73" d="100"/>
          <a:sy n="73" d="100"/>
        </p:scale>
        <p:origin x="1820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F943553-BB1D-4561-998A-3E90FED4F703}" type="datetimeFigureOut">
              <a:rPr lang="zh-CN" altLang="en-US" smtClean="0"/>
              <a:t>2025/11/8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05A6A50-45DA-416A-973A-5CC974BB33B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8444759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4BD2E0-B931-4D6E-BAB0-FADEA635A0B2}" type="datetimeFigureOut">
              <a:rPr lang="zh-CN" altLang="en-US" smtClean="0"/>
              <a:t>2025/11/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FD7E8A-851B-4023-85CD-46A3359E3A9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869410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4BD2E0-B931-4D6E-BAB0-FADEA635A0B2}" type="datetimeFigureOut">
              <a:rPr lang="zh-CN" altLang="en-US" smtClean="0"/>
              <a:t>2025/11/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FD7E8A-851B-4023-85CD-46A3359E3A9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077410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4BD2E0-B931-4D6E-BAB0-FADEA635A0B2}" type="datetimeFigureOut">
              <a:rPr lang="zh-CN" altLang="en-US" smtClean="0"/>
              <a:t>2025/11/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FD7E8A-851B-4023-85CD-46A3359E3A9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549627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4BD2E0-B931-4D6E-BAB0-FADEA635A0B2}" type="datetimeFigureOut">
              <a:rPr lang="zh-CN" altLang="en-US" smtClean="0"/>
              <a:t>2025/11/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FD7E8A-851B-4023-85CD-46A3359E3A9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874604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4BD2E0-B931-4D6E-BAB0-FADEA635A0B2}" type="datetimeFigureOut">
              <a:rPr lang="zh-CN" altLang="en-US" smtClean="0"/>
              <a:t>2025/11/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FD7E8A-851B-4023-85CD-46A3359E3A9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495578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4BD2E0-B931-4D6E-BAB0-FADEA635A0B2}" type="datetimeFigureOut">
              <a:rPr lang="zh-CN" altLang="en-US" smtClean="0"/>
              <a:t>2025/11/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FD7E8A-851B-4023-85CD-46A3359E3A9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993293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4BD2E0-B931-4D6E-BAB0-FADEA635A0B2}" type="datetimeFigureOut">
              <a:rPr lang="zh-CN" altLang="en-US" smtClean="0"/>
              <a:t>2025/11/8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FD7E8A-851B-4023-85CD-46A3359E3A9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281730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4BD2E0-B931-4D6E-BAB0-FADEA635A0B2}" type="datetimeFigureOut">
              <a:rPr lang="zh-CN" altLang="en-US" smtClean="0"/>
              <a:t>2025/11/8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FD7E8A-851B-4023-85CD-46A3359E3A9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036256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4BD2E0-B931-4D6E-BAB0-FADEA635A0B2}" type="datetimeFigureOut">
              <a:rPr lang="zh-CN" altLang="en-US" smtClean="0"/>
              <a:t>2025/11/8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FD7E8A-851B-4023-85CD-46A3359E3A9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61490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4BD2E0-B931-4D6E-BAB0-FADEA635A0B2}" type="datetimeFigureOut">
              <a:rPr lang="zh-CN" altLang="en-US" smtClean="0"/>
              <a:t>2025/11/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FD7E8A-851B-4023-85CD-46A3359E3A9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757415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4BD2E0-B931-4D6E-BAB0-FADEA635A0B2}" type="datetimeFigureOut">
              <a:rPr lang="zh-CN" altLang="en-US" smtClean="0"/>
              <a:t>2025/11/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FD7E8A-851B-4023-85CD-46A3359E3A9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56402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4BD2E0-B931-4D6E-BAB0-FADEA635A0B2}" type="datetimeFigureOut">
              <a:rPr lang="zh-CN" altLang="en-US" smtClean="0"/>
              <a:t>2025/11/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2FD7E8A-851B-4023-85CD-46A3359E3A9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818106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13" Type="http://schemas.openxmlformats.org/officeDocument/2006/relationships/image" Target="../media/image12.jpeg"/><Relationship Id="rId18" Type="http://schemas.openxmlformats.org/officeDocument/2006/relationships/image" Target="../media/image17.jpeg"/><Relationship Id="rId26" Type="http://schemas.openxmlformats.org/officeDocument/2006/relationships/image" Target="../media/image25.jpeg"/><Relationship Id="rId3" Type="http://schemas.openxmlformats.org/officeDocument/2006/relationships/image" Target="../media/image2.jpeg"/><Relationship Id="rId21" Type="http://schemas.openxmlformats.org/officeDocument/2006/relationships/image" Target="../media/image20.jpeg"/><Relationship Id="rId7" Type="http://schemas.openxmlformats.org/officeDocument/2006/relationships/image" Target="../media/image6.jpeg"/><Relationship Id="rId12" Type="http://schemas.openxmlformats.org/officeDocument/2006/relationships/image" Target="../media/image11.jpeg"/><Relationship Id="rId17" Type="http://schemas.openxmlformats.org/officeDocument/2006/relationships/image" Target="../media/image16.jpeg"/><Relationship Id="rId25" Type="http://schemas.openxmlformats.org/officeDocument/2006/relationships/image" Target="../media/image24.jpeg"/><Relationship Id="rId2" Type="http://schemas.openxmlformats.org/officeDocument/2006/relationships/image" Target="../media/image1.jpeg"/><Relationship Id="rId16" Type="http://schemas.openxmlformats.org/officeDocument/2006/relationships/image" Target="../media/image15.jpeg"/><Relationship Id="rId20" Type="http://schemas.openxmlformats.org/officeDocument/2006/relationships/image" Target="../media/image19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eg"/><Relationship Id="rId11" Type="http://schemas.openxmlformats.org/officeDocument/2006/relationships/image" Target="../media/image10.jpeg"/><Relationship Id="rId24" Type="http://schemas.openxmlformats.org/officeDocument/2006/relationships/image" Target="../media/image23.jpeg"/><Relationship Id="rId5" Type="http://schemas.openxmlformats.org/officeDocument/2006/relationships/image" Target="../media/image4.jpeg"/><Relationship Id="rId15" Type="http://schemas.openxmlformats.org/officeDocument/2006/relationships/image" Target="../media/image14.jpeg"/><Relationship Id="rId23" Type="http://schemas.openxmlformats.org/officeDocument/2006/relationships/image" Target="../media/image22.jpeg"/><Relationship Id="rId10" Type="http://schemas.openxmlformats.org/officeDocument/2006/relationships/image" Target="../media/image9.jpeg"/><Relationship Id="rId19" Type="http://schemas.openxmlformats.org/officeDocument/2006/relationships/image" Target="../media/image18.jpeg"/><Relationship Id="rId4" Type="http://schemas.openxmlformats.org/officeDocument/2006/relationships/image" Target="../media/image3.jpeg"/><Relationship Id="rId9" Type="http://schemas.openxmlformats.org/officeDocument/2006/relationships/image" Target="../media/image8.jpeg"/><Relationship Id="rId14" Type="http://schemas.openxmlformats.org/officeDocument/2006/relationships/image" Target="../media/image13.jpeg"/><Relationship Id="rId22" Type="http://schemas.openxmlformats.org/officeDocument/2006/relationships/image" Target="../media/image21.jpeg"/><Relationship Id="rId27" Type="http://schemas.openxmlformats.org/officeDocument/2006/relationships/image" Target="../media/image26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图片 10">
            <a:extLst>
              <a:ext uri="{FF2B5EF4-FFF2-40B4-BE49-F238E27FC236}">
                <a16:creationId xmlns:a16="http://schemas.microsoft.com/office/drawing/2014/main" id="{0DD13EFE-A828-FB16-8C38-487AB679CD3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98657" y="702275"/>
            <a:ext cx="1277322" cy="1021010"/>
          </a:xfrm>
          <a:custGeom>
            <a:avLst/>
            <a:gdLst>
              <a:gd name="connsiteX0" fmla="*/ 496 w 1277322"/>
              <a:gd name="connsiteY0" fmla="*/ -152 h 1021010"/>
              <a:gd name="connsiteX1" fmla="*/ 1277818 w 1277322"/>
              <a:gd name="connsiteY1" fmla="*/ -152 h 1021010"/>
              <a:gd name="connsiteX2" fmla="*/ 1277818 w 1277322"/>
              <a:gd name="connsiteY2" fmla="*/ 1020859 h 1021010"/>
              <a:gd name="connsiteX3" fmla="*/ 496 w 1277322"/>
              <a:gd name="connsiteY3" fmla="*/ 1020859 h 102101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277322" h="1021010">
                <a:moveTo>
                  <a:pt x="496" y="-152"/>
                </a:moveTo>
                <a:lnTo>
                  <a:pt x="1277818" y="-152"/>
                </a:lnTo>
                <a:lnTo>
                  <a:pt x="1277818" y="1020859"/>
                </a:lnTo>
                <a:lnTo>
                  <a:pt x="496" y="1020859"/>
                </a:lnTo>
                <a:close/>
              </a:path>
            </a:pathLst>
          </a:custGeom>
        </p:spPr>
      </p:pic>
      <p:pic>
        <p:nvPicPr>
          <p:cNvPr id="12" name="图片 11">
            <a:extLst>
              <a:ext uri="{FF2B5EF4-FFF2-40B4-BE49-F238E27FC236}">
                <a16:creationId xmlns:a16="http://schemas.microsoft.com/office/drawing/2014/main" id="{E3A8AF49-3534-4C2F-7337-199E03DADB3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790337" y="1747985"/>
            <a:ext cx="1277321" cy="1025124"/>
          </a:xfrm>
          <a:custGeom>
            <a:avLst/>
            <a:gdLst>
              <a:gd name="connsiteX0" fmla="*/ 496 w 1277317"/>
              <a:gd name="connsiteY0" fmla="*/ 140 h 1025124"/>
              <a:gd name="connsiteX1" fmla="*/ 1277813 w 1277317"/>
              <a:gd name="connsiteY1" fmla="*/ 140 h 1025124"/>
              <a:gd name="connsiteX2" fmla="*/ 1277813 w 1277317"/>
              <a:gd name="connsiteY2" fmla="*/ 1025265 h 1025124"/>
              <a:gd name="connsiteX3" fmla="*/ 496 w 1277317"/>
              <a:gd name="connsiteY3" fmla="*/ 1025265 h 102512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277317" h="1025124">
                <a:moveTo>
                  <a:pt x="496" y="140"/>
                </a:moveTo>
                <a:lnTo>
                  <a:pt x="1277813" y="140"/>
                </a:lnTo>
                <a:lnTo>
                  <a:pt x="1277813" y="1025265"/>
                </a:lnTo>
                <a:lnTo>
                  <a:pt x="496" y="1025265"/>
                </a:lnTo>
                <a:close/>
              </a:path>
            </a:pathLst>
          </a:custGeom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C9F738A4-960F-5EE6-1CF4-89C2A41BC9D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110631" y="706387"/>
            <a:ext cx="1277317" cy="1016897"/>
          </a:xfrm>
          <a:custGeom>
            <a:avLst/>
            <a:gdLst>
              <a:gd name="connsiteX0" fmla="*/ 839 w 1277317"/>
              <a:gd name="connsiteY0" fmla="*/ -149 h 1025124"/>
              <a:gd name="connsiteX1" fmla="*/ 1278156 w 1277317"/>
              <a:gd name="connsiteY1" fmla="*/ -149 h 1025124"/>
              <a:gd name="connsiteX2" fmla="*/ 1278156 w 1277317"/>
              <a:gd name="connsiteY2" fmla="*/ 1024976 h 1025124"/>
              <a:gd name="connsiteX3" fmla="*/ 839 w 1277317"/>
              <a:gd name="connsiteY3" fmla="*/ 1024976 h 102512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277317" h="1025124">
                <a:moveTo>
                  <a:pt x="839" y="-149"/>
                </a:moveTo>
                <a:lnTo>
                  <a:pt x="1278156" y="-149"/>
                </a:lnTo>
                <a:lnTo>
                  <a:pt x="1278156" y="1024976"/>
                </a:lnTo>
                <a:lnTo>
                  <a:pt x="839" y="1024976"/>
                </a:lnTo>
                <a:close/>
              </a:path>
            </a:pathLst>
          </a:custGeom>
        </p:spPr>
      </p:pic>
      <p:pic>
        <p:nvPicPr>
          <p:cNvPr id="14" name="图片 13">
            <a:extLst>
              <a:ext uri="{FF2B5EF4-FFF2-40B4-BE49-F238E27FC236}">
                <a16:creationId xmlns:a16="http://schemas.microsoft.com/office/drawing/2014/main" id="{A2A89AFB-D4B9-C04E-C35E-CBDE0E02D2E0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110626" y="1747985"/>
            <a:ext cx="1277322" cy="1037481"/>
          </a:xfrm>
          <a:custGeom>
            <a:avLst/>
            <a:gdLst>
              <a:gd name="connsiteX0" fmla="*/ 841 w 1293799"/>
              <a:gd name="connsiteY0" fmla="*/ 137 h 1037481"/>
              <a:gd name="connsiteX1" fmla="*/ 1294640 w 1293799"/>
              <a:gd name="connsiteY1" fmla="*/ 137 h 1037481"/>
              <a:gd name="connsiteX2" fmla="*/ 1294640 w 1293799"/>
              <a:gd name="connsiteY2" fmla="*/ 1037618 h 1037481"/>
              <a:gd name="connsiteX3" fmla="*/ 841 w 1293799"/>
              <a:gd name="connsiteY3" fmla="*/ 1037618 h 1037481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293799" h="1037481">
                <a:moveTo>
                  <a:pt x="841" y="137"/>
                </a:moveTo>
                <a:lnTo>
                  <a:pt x="1294640" y="137"/>
                </a:lnTo>
                <a:lnTo>
                  <a:pt x="1294640" y="1037618"/>
                </a:lnTo>
                <a:lnTo>
                  <a:pt x="841" y="1037618"/>
                </a:lnTo>
                <a:close/>
              </a:path>
            </a:pathLst>
          </a:custGeom>
        </p:spPr>
      </p:pic>
      <p:pic>
        <p:nvPicPr>
          <p:cNvPr id="15" name="图片 14">
            <a:extLst>
              <a:ext uri="{FF2B5EF4-FFF2-40B4-BE49-F238E27FC236}">
                <a16:creationId xmlns:a16="http://schemas.microsoft.com/office/drawing/2014/main" id="{8AF77E07-0CF7-5EBC-9DC5-F2484C5662F0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422600" y="706393"/>
            <a:ext cx="1277317" cy="1016891"/>
          </a:xfrm>
          <a:custGeom>
            <a:avLst/>
            <a:gdLst>
              <a:gd name="connsiteX0" fmla="*/ 1184 w 1277317"/>
              <a:gd name="connsiteY0" fmla="*/ -148 h 1025124"/>
              <a:gd name="connsiteX1" fmla="*/ 1278501 w 1277317"/>
              <a:gd name="connsiteY1" fmla="*/ -148 h 1025124"/>
              <a:gd name="connsiteX2" fmla="*/ 1278501 w 1277317"/>
              <a:gd name="connsiteY2" fmla="*/ 1024977 h 1025124"/>
              <a:gd name="connsiteX3" fmla="*/ 1184 w 1277317"/>
              <a:gd name="connsiteY3" fmla="*/ 1024977 h 102512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277317" h="1025124">
                <a:moveTo>
                  <a:pt x="1184" y="-148"/>
                </a:moveTo>
                <a:lnTo>
                  <a:pt x="1278501" y="-148"/>
                </a:lnTo>
                <a:lnTo>
                  <a:pt x="1278501" y="1024977"/>
                </a:lnTo>
                <a:lnTo>
                  <a:pt x="1184" y="1024977"/>
                </a:lnTo>
                <a:close/>
              </a:path>
            </a:pathLst>
          </a:custGeom>
        </p:spPr>
      </p:pic>
      <p:pic>
        <p:nvPicPr>
          <p:cNvPr id="16" name="图片 15">
            <a:extLst>
              <a:ext uri="{FF2B5EF4-FFF2-40B4-BE49-F238E27FC236}">
                <a16:creationId xmlns:a16="http://schemas.microsoft.com/office/drawing/2014/main" id="{2AC05341-A42C-F4A9-8FD2-A85E293EB3F3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422600" y="1747985"/>
            <a:ext cx="1277317" cy="1025124"/>
          </a:xfrm>
          <a:custGeom>
            <a:avLst/>
            <a:gdLst>
              <a:gd name="connsiteX0" fmla="*/ 1187 w 1277317"/>
              <a:gd name="connsiteY0" fmla="*/ 133 h 1025124"/>
              <a:gd name="connsiteX1" fmla="*/ 1278504 w 1277317"/>
              <a:gd name="connsiteY1" fmla="*/ 133 h 1025124"/>
              <a:gd name="connsiteX2" fmla="*/ 1278504 w 1277317"/>
              <a:gd name="connsiteY2" fmla="*/ 1025258 h 1025124"/>
              <a:gd name="connsiteX3" fmla="*/ 1187 w 1277317"/>
              <a:gd name="connsiteY3" fmla="*/ 1025258 h 102512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277317" h="1025124">
                <a:moveTo>
                  <a:pt x="1187" y="133"/>
                </a:moveTo>
                <a:lnTo>
                  <a:pt x="1278504" y="133"/>
                </a:lnTo>
                <a:lnTo>
                  <a:pt x="1278504" y="1025258"/>
                </a:lnTo>
                <a:lnTo>
                  <a:pt x="1187" y="1025258"/>
                </a:lnTo>
                <a:close/>
              </a:path>
            </a:pathLst>
          </a:custGeom>
        </p:spPr>
      </p:pic>
      <p:pic>
        <p:nvPicPr>
          <p:cNvPr id="17" name="图片 16">
            <a:extLst>
              <a:ext uri="{FF2B5EF4-FFF2-40B4-BE49-F238E27FC236}">
                <a16:creationId xmlns:a16="http://schemas.microsoft.com/office/drawing/2014/main" id="{148BF5D9-1477-6466-8E86-7ABFCA2265A1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73984" y="702275"/>
            <a:ext cx="1277322" cy="1021010"/>
          </a:xfrm>
          <a:custGeom>
            <a:avLst/>
            <a:gdLst>
              <a:gd name="connsiteX0" fmla="*/ -182 w 1277322"/>
              <a:gd name="connsiteY0" fmla="*/ -152 h 1021010"/>
              <a:gd name="connsiteX1" fmla="*/ 1277140 w 1277322"/>
              <a:gd name="connsiteY1" fmla="*/ -152 h 1021010"/>
              <a:gd name="connsiteX2" fmla="*/ 1277140 w 1277322"/>
              <a:gd name="connsiteY2" fmla="*/ 1020859 h 1021010"/>
              <a:gd name="connsiteX3" fmla="*/ -182 w 1277322"/>
              <a:gd name="connsiteY3" fmla="*/ 1020859 h 102101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277322" h="1021010">
                <a:moveTo>
                  <a:pt x="-182" y="-152"/>
                </a:moveTo>
                <a:lnTo>
                  <a:pt x="1277140" y="-152"/>
                </a:lnTo>
                <a:lnTo>
                  <a:pt x="1277140" y="1020859"/>
                </a:lnTo>
                <a:lnTo>
                  <a:pt x="-182" y="1020859"/>
                </a:lnTo>
                <a:close/>
              </a:path>
            </a:pathLst>
          </a:custGeom>
        </p:spPr>
      </p:pic>
      <p:pic>
        <p:nvPicPr>
          <p:cNvPr id="18" name="图片 17">
            <a:extLst>
              <a:ext uri="{FF2B5EF4-FFF2-40B4-BE49-F238E27FC236}">
                <a16:creationId xmlns:a16="http://schemas.microsoft.com/office/drawing/2014/main" id="{E833558C-FB48-FC8B-9BD6-D847501EE4DF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73984" y="1739749"/>
            <a:ext cx="1277317" cy="1041597"/>
          </a:xfrm>
          <a:custGeom>
            <a:avLst/>
            <a:gdLst>
              <a:gd name="connsiteX0" fmla="*/ -186 w 1297919"/>
              <a:gd name="connsiteY0" fmla="*/ 142 h 1041597"/>
              <a:gd name="connsiteX1" fmla="*/ 1297734 w 1297919"/>
              <a:gd name="connsiteY1" fmla="*/ 142 h 1041597"/>
              <a:gd name="connsiteX2" fmla="*/ 1297734 w 1297919"/>
              <a:gd name="connsiteY2" fmla="*/ 1041740 h 1041597"/>
              <a:gd name="connsiteX3" fmla="*/ -186 w 1297919"/>
              <a:gd name="connsiteY3" fmla="*/ 1041740 h 104159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297919" h="1041597">
                <a:moveTo>
                  <a:pt x="-186" y="142"/>
                </a:moveTo>
                <a:lnTo>
                  <a:pt x="1297734" y="142"/>
                </a:lnTo>
                <a:lnTo>
                  <a:pt x="1297734" y="1041740"/>
                </a:lnTo>
                <a:lnTo>
                  <a:pt x="-186" y="1041740"/>
                </a:lnTo>
                <a:close/>
              </a:path>
            </a:pathLst>
          </a:custGeom>
        </p:spPr>
      </p:pic>
      <p:pic>
        <p:nvPicPr>
          <p:cNvPr id="19" name="图片 18">
            <a:extLst>
              <a:ext uri="{FF2B5EF4-FFF2-40B4-BE49-F238E27FC236}">
                <a16:creationId xmlns:a16="http://schemas.microsoft.com/office/drawing/2014/main" id="{2FD38D4C-FF5E-8861-011C-88C7F54DBFAA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1486323" y="698161"/>
            <a:ext cx="1277317" cy="1025124"/>
          </a:xfrm>
          <a:custGeom>
            <a:avLst/>
            <a:gdLst>
              <a:gd name="connsiteX0" fmla="*/ 152 w 1277317"/>
              <a:gd name="connsiteY0" fmla="*/ -149 h 1025124"/>
              <a:gd name="connsiteX1" fmla="*/ 1277469 w 1277317"/>
              <a:gd name="connsiteY1" fmla="*/ -149 h 1025124"/>
              <a:gd name="connsiteX2" fmla="*/ 1277469 w 1277317"/>
              <a:gd name="connsiteY2" fmla="*/ 1024976 h 1025124"/>
              <a:gd name="connsiteX3" fmla="*/ 152 w 1277317"/>
              <a:gd name="connsiteY3" fmla="*/ 1024976 h 102512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277317" h="1025124">
                <a:moveTo>
                  <a:pt x="152" y="-149"/>
                </a:moveTo>
                <a:lnTo>
                  <a:pt x="1277469" y="-149"/>
                </a:lnTo>
                <a:lnTo>
                  <a:pt x="1277469" y="1024976"/>
                </a:lnTo>
                <a:lnTo>
                  <a:pt x="152" y="1024976"/>
                </a:lnTo>
                <a:close/>
              </a:path>
            </a:pathLst>
          </a:custGeom>
        </p:spPr>
      </p:pic>
      <p:pic>
        <p:nvPicPr>
          <p:cNvPr id="20" name="图片 19">
            <a:extLst>
              <a:ext uri="{FF2B5EF4-FFF2-40B4-BE49-F238E27FC236}">
                <a16:creationId xmlns:a16="http://schemas.microsoft.com/office/drawing/2014/main" id="{4B809C72-851A-5BB0-BD0B-FC21816CEEE5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1486325" y="1747985"/>
            <a:ext cx="1277316" cy="1025124"/>
          </a:xfrm>
          <a:custGeom>
            <a:avLst/>
            <a:gdLst>
              <a:gd name="connsiteX0" fmla="*/ 152 w 1277317"/>
              <a:gd name="connsiteY0" fmla="*/ 144 h 1025124"/>
              <a:gd name="connsiteX1" fmla="*/ 1277469 w 1277317"/>
              <a:gd name="connsiteY1" fmla="*/ 144 h 1025124"/>
              <a:gd name="connsiteX2" fmla="*/ 1277469 w 1277317"/>
              <a:gd name="connsiteY2" fmla="*/ 1025269 h 1025124"/>
              <a:gd name="connsiteX3" fmla="*/ 152 w 1277317"/>
              <a:gd name="connsiteY3" fmla="*/ 1025269 h 102512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277317" h="1025124">
                <a:moveTo>
                  <a:pt x="152" y="144"/>
                </a:moveTo>
                <a:lnTo>
                  <a:pt x="1277469" y="144"/>
                </a:lnTo>
                <a:lnTo>
                  <a:pt x="1277469" y="1025269"/>
                </a:lnTo>
                <a:lnTo>
                  <a:pt x="152" y="1025269"/>
                </a:lnTo>
                <a:close/>
              </a:path>
            </a:pathLst>
          </a:custGeom>
        </p:spPr>
      </p:pic>
      <p:sp>
        <p:nvSpPr>
          <p:cNvPr id="21" name="文本框 20">
            <a:extLst>
              <a:ext uri="{FF2B5EF4-FFF2-40B4-BE49-F238E27FC236}">
                <a16:creationId xmlns:a16="http://schemas.microsoft.com/office/drawing/2014/main" id="{745954D0-15AF-4768-C32C-69977E4B48A2}"/>
              </a:ext>
            </a:extLst>
          </p:cNvPr>
          <p:cNvSpPr txBox="1"/>
          <p:nvPr/>
        </p:nvSpPr>
        <p:spPr>
          <a:xfrm>
            <a:off x="1842527" y="392886"/>
            <a:ext cx="7481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4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C0FDA417-073A-A780-A59D-1FFCD7B0BBAF}"/>
              </a:ext>
            </a:extLst>
          </p:cNvPr>
          <p:cNvSpPr txBox="1"/>
          <p:nvPr/>
        </p:nvSpPr>
        <p:spPr>
          <a:xfrm>
            <a:off x="3138980" y="400576"/>
            <a:ext cx="7481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8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BA7228AD-4C1E-3DA9-01E8-A6D8AF81DD16}"/>
              </a:ext>
            </a:extLst>
          </p:cNvPr>
          <p:cNvSpPr txBox="1"/>
          <p:nvPr/>
        </p:nvSpPr>
        <p:spPr>
          <a:xfrm>
            <a:off x="4375216" y="400575"/>
            <a:ext cx="7481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68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404B4E22-FC6C-FEA0-9BFC-8927C35B3019}"/>
              </a:ext>
            </a:extLst>
          </p:cNvPr>
          <p:cNvSpPr txBox="1"/>
          <p:nvPr/>
        </p:nvSpPr>
        <p:spPr>
          <a:xfrm>
            <a:off x="5839391" y="392885"/>
            <a:ext cx="7129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D-1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3BF86AC7-0C5C-682F-ECC4-616E81A995BD}"/>
              </a:ext>
            </a:extLst>
          </p:cNvPr>
          <p:cNvSpPr txBox="1"/>
          <p:nvPr/>
        </p:nvSpPr>
        <p:spPr>
          <a:xfrm>
            <a:off x="546074" y="400575"/>
            <a:ext cx="7481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3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8C80B7D4-0974-74AB-8332-72DA50D6D380}"/>
              </a:ext>
            </a:extLst>
          </p:cNvPr>
          <p:cNvSpPr txBox="1"/>
          <p:nvPr/>
        </p:nvSpPr>
        <p:spPr>
          <a:xfrm rot="16200000">
            <a:off x="-772379" y="714217"/>
            <a:ext cx="16746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e-treatment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EA3F5F31-BFA8-17E1-993A-960D2C96A2DF}"/>
              </a:ext>
            </a:extLst>
          </p:cNvPr>
          <p:cNvSpPr txBox="1"/>
          <p:nvPr/>
        </p:nvSpPr>
        <p:spPr>
          <a:xfrm rot="16200000">
            <a:off x="-776827" y="1792835"/>
            <a:ext cx="171432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ost-treatment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2" name="图片 51">
            <a:extLst>
              <a:ext uri="{FF2B5EF4-FFF2-40B4-BE49-F238E27FC236}">
                <a16:creationId xmlns:a16="http://schemas.microsoft.com/office/drawing/2014/main" id="{92B01732-2ED8-4E32-132C-970FCC9F298B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805618" y="3573099"/>
            <a:ext cx="1283456" cy="1030448"/>
          </a:xfrm>
          <a:custGeom>
            <a:avLst/>
            <a:gdLst>
              <a:gd name="connsiteX0" fmla="*/ -174 w 1283456"/>
              <a:gd name="connsiteY0" fmla="*/ -138 h 1030448"/>
              <a:gd name="connsiteX1" fmla="*/ 1283283 w 1283456"/>
              <a:gd name="connsiteY1" fmla="*/ -138 h 1030448"/>
              <a:gd name="connsiteX2" fmla="*/ 1283283 w 1283456"/>
              <a:gd name="connsiteY2" fmla="*/ 1030311 h 1030448"/>
              <a:gd name="connsiteX3" fmla="*/ -174 w 1283456"/>
              <a:gd name="connsiteY3" fmla="*/ 1030311 h 103044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283456" h="1030448">
                <a:moveTo>
                  <a:pt x="-174" y="-138"/>
                </a:moveTo>
                <a:lnTo>
                  <a:pt x="1283283" y="-138"/>
                </a:lnTo>
                <a:lnTo>
                  <a:pt x="1283283" y="1030311"/>
                </a:lnTo>
                <a:lnTo>
                  <a:pt x="-174" y="1030311"/>
                </a:lnTo>
                <a:close/>
              </a:path>
            </a:pathLst>
          </a:custGeom>
        </p:spPr>
      </p:pic>
      <p:pic>
        <p:nvPicPr>
          <p:cNvPr id="53" name="图片 52">
            <a:extLst>
              <a:ext uri="{FF2B5EF4-FFF2-40B4-BE49-F238E27FC236}">
                <a16:creationId xmlns:a16="http://schemas.microsoft.com/office/drawing/2014/main" id="{DD2B26CB-38DC-FE51-2241-81FBFF938FB2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805618" y="4637395"/>
            <a:ext cx="1283456" cy="1030448"/>
          </a:xfrm>
          <a:custGeom>
            <a:avLst/>
            <a:gdLst>
              <a:gd name="connsiteX0" fmla="*/ -174 w 1283456"/>
              <a:gd name="connsiteY0" fmla="*/ 145 h 1030448"/>
              <a:gd name="connsiteX1" fmla="*/ 1283283 w 1283456"/>
              <a:gd name="connsiteY1" fmla="*/ 145 h 1030448"/>
              <a:gd name="connsiteX2" fmla="*/ 1283283 w 1283456"/>
              <a:gd name="connsiteY2" fmla="*/ 1030594 h 1030448"/>
              <a:gd name="connsiteX3" fmla="*/ -174 w 1283456"/>
              <a:gd name="connsiteY3" fmla="*/ 1030594 h 103044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283456" h="1030448">
                <a:moveTo>
                  <a:pt x="-174" y="145"/>
                </a:moveTo>
                <a:lnTo>
                  <a:pt x="1283283" y="145"/>
                </a:lnTo>
                <a:lnTo>
                  <a:pt x="1283283" y="1030594"/>
                </a:lnTo>
                <a:lnTo>
                  <a:pt x="-174" y="1030594"/>
                </a:lnTo>
                <a:close/>
              </a:path>
            </a:pathLst>
          </a:custGeom>
        </p:spPr>
      </p:pic>
      <p:pic>
        <p:nvPicPr>
          <p:cNvPr id="54" name="图片 53">
            <a:extLst>
              <a:ext uri="{FF2B5EF4-FFF2-40B4-BE49-F238E27FC236}">
                <a16:creationId xmlns:a16="http://schemas.microsoft.com/office/drawing/2014/main" id="{E551FBEC-A732-CC05-4630-CD4F3A1C5256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2131321" y="3583995"/>
            <a:ext cx="1264637" cy="1015399"/>
          </a:xfrm>
          <a:custGeom>
            <a:avLst/>
            <a:gdLst>
              <a:gd name="connsiteX0" fmla="*/ 180 w 1264637"/>
              <a:gd name="connsiteY0" fmla="*/ -138 h 1015399"/>
              <a:gd name="connsiteX1" fmla="*/ 1264817 w 1264637"/>
              <a:gd name="connsiteY1" fmla="*/ -138 h 1015399"/>
              <a:gd name="connsiteX2" fmla="*/ 1264817 w 1264637"/>
              <a:gd name="connsiteY2" fmla="*/ 1015262 h 1015399"/>
              <a:gd name="connsiteX3" fmla="*/ 180 w 1264637"/>
              <a:gd name="connsiteY3" fmla="*/ 1015262 h 101539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264637" h="1015399">
                <a:moveTo>
                  <a:pt x="180" y="-138"/>
                </a:moveTo>
                <a:lnTo>
                  <a:pt x="1264817" y="-138"/>
                </a:lnTo>
                <a:lnTo>
                  <a:pt x="1264817" y="1015262"/>
                </a:lnTo>
                <a:lnTo>
                  <a:pt x="180" y="1015262"/>
                </a:lnTo>
                <a:close/>
              </a:path>
            </a:pathLst>
          </a:custGeom>
        </p:spPr>
      </p:pic>
      <p:pic>
        <p:nvPicPr>
          <p:cNvPr id="55" name="图片 54">
            <a:extLst>
              <a:ext uri="{FF2B5EF4-FFF2-40B4-BE49-F238E27FC236}">
                <a16:creationId xmlns:a16="http://schemas.microsoft.com/office/drawing/2014/main" id="{589207DF-63D8-5FFD-A2C2-C04B5574D0F9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2131563" y="4633634"/>
            <a:ext cx="1264637" cy="1015399"/>
          </a:xfrm>
          <a:custGeom>
            <a:avLst/>
            <a:gdLst>
              <a:gd name="connsiteX0" fmla="*/ 180 w 1264637"/>
              <a:gd name="connsiteY0" fmla="*/ 143 h 1015399"/>
              <a:gd name="connsiteX1" fmla="*/ 1264817 w 1264637"/>
              <a:gd name="connsiteY1" fmla="*/ 143 h 1015399"/>
              <a:gd name="connsiteX2" fmla="*/ 1264817 w 1264637"/>
              <a:gd name="connsiteY2" fmla="*/ 1015543 h 1015399"/>
              <a:gd name="connsiteX3" fmla="*/ 180 w 1264637"/>
              <a:gd name="connsiteY3" fmla="*/ 1015543 h 101539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264637" h="1015399">
                <a:moveTo>
                  <a:pt x="180" y="143"/>
                </a:moveTo>
                <a:lnTo>
                  <a:pt x="1264817" y="143"/>
                </a:lnTo>
                <a:lnTo>
                  <a:pt x="1264817" y="1015543"/>
                </a:lnTo>
                <a:lnTo>
                  <a:pt x="180" y="1015543"/>
                </a:lnTo>
                <a:close/>
              </a:path>
            </a:pathLst>
          </a:custGeom>
        </p:spPr>
      </p:pic>
      <p:pic>
        <p:nvPicPr>
          <p:cNvPr id="58" name="图片 57">
            <a:extLst>
              <a:ext uri="{FF2B5EF4-FFF2-40B4-BE49-F238E27FC236}">
                <a16:creationId xmlns:a16="http://schemas.microsoft.com/office/drawing/2014/main" id="{1D64E573-5D6E-3591-CC5C-9B34C3C50088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3438205" y="3583903"/>
            <a:ext cx="1260873" cy="1011639"/>
          </a:xfrm>
          <a:custGeom>
            <a:avLst/>
            <a:gdLst>
              <a:gd name="connsiteX0" fmla="*/ 875 w 1260873"/>
              <a:gd name="connsiteY0" fmla="*/ -137 h 1011639"/>
              <a:gd name="connsiteX1" fmla="*/ 1261749 w 1260873"/>
              <a:gd name="connsiteY1" fmla="*/ -137 h 1011639"/>
              <a:gd name="connsiteX2" fmla="*/ 1261749 w 1260873"/>
              <a:gd name="connsiteY2" fmla="*/ 1011503 h 1011639"/>
              <a:gd name="connsiteX3" fmla="*/ 875 w 1260873"/>
              <a:gd name="connsiteY3" fmla="*/ 1011503 h 101163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260873" h="1011639">
                <a:moveTo>
                  <a:pt x="875" y="-137"/>
                </a:moveTo>
                <a:lnTo>
                  <a:pt x="1261749" y="-137"/>
                </a:lnTo>
                <a:lnTo>
                  <a:pt x="1261749" y="1011503"/>
                </a:lnTo>
                <a:lnTo>
                  <a:pt x="875" y="1011503"/>
                </a:lnTo>
                <a:close/>
              </a:path>
            </a:pathLst>
          </a:custGeom>
        </p:spPr>
      </p:pic>
      <p:pic>
        <p:nvPicPr>
          <p:cNvPr id="59" name="图片 58">
            <a:extLst>
              <a:ext uri="{FF2B5EF4-FFF2-40B4-BE49-F238E27FC236}">
                <a16:creationId xmlns:a16="http://schemas.microsoft.com/office/drawing/2014/main" id="{3692E380-08F6-3D51-EA4A-CAB2DC52E4E7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3438205" y="4629395"/>
            <a:ext cx="1260873" cy="1011639"/>
          </a:xfrm>
          <a:custGeom>
            <a:avLst/>
            <a:gdLst>
              <a:gd name="connsiteX0" fmla="*/ 875 w 1260873"/>
              <a:gd name="connsiteY0" fmla="*/ 141 h 1011639"/>
              <a:gd name="connsiteX1" fmla="*/ 1261749 w 1260873"/>
              <a:gd name="connsiteY1" fmla="*/ 141 h 1011639"/>
              <a:gd name="connsiteX2" fmla="*/ 1261749 w 1260873"/>
              <a:gd name="connsiteY2" fmla="*/ 1011781 h 1011639"/>
              <a:gd name="connsiteX3" fmla="*/ 875 w 1260873"/>
              <a:gd name="connsiteY3" fmla="*/ 1011781 h 101163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260873" h="1011639">
                <a:moveTo>
                  <a:pt x="875" y="141"/>
                </a:moveTo>
                <a:lnTo>
                  <a:pt x="1261749" y="141"/>
                </a:lnTo>
                <a:lnTo>
                  <a:pt x="1261749" y="1011781"/>
                </a:lnTo>
                <a:lnTo>
                  <a:pt x="875" y="1011781"/>
                </a:lnTo>
                <a:close/>
              </a:path>
            </a:pathLst>
          </a:custGeom>
        </p:spPr>
      </p:pic>
      <p:pic>
        <p:nvPicPr>
          <p:cNvPr id="60" name="图片 59">
            <a:extLst>
              <a:ext uri="{FF2B5EF4-FFF2-40B4-BE49-F238E27FC236}">
                <a16:creationId xmlns:a16="http://schemas.microsoft.com/office/drawing/2014/main" id="{A8159162-AF4D-0A10-EB9E-771D4112BF3C}"/>
              </a:ext>
            </a:extLst>
          </p:cNvPr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4732956" y="4633156"/>
            <a:ext cx="1257113" cy="1004122"/>
          </a:xfrm>
          <a:custGeom>
            <a:avLst/>
            <a:gdLst>
              <a:gd name="connsiteX0" fmla="*/ 1219 w 1257113"/>
              <a:gd name="connsiteY0" fmla="*/ 141 h 1004122"/>
              <a:gd name="connsiteX1" fmla="*/ 1258333 w 1257113"/>
              <a:gd name="connsiteY1" fmla="*/ 141 h 1004122"/>
              <a:gd name="connsiteX2" fmla="*/ 1258333 w 1257113"/>
              <a:gd name="connsiteY2" fmla="*/ 1004264 h 1004122"/>
              <a:gd name="connsiteX3" fmla="*/ 1219 w 1257113"/>
              <a:gd name="connsiteY3" fmla="*/ 1004264 h 100412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257113" h="1004122">
                <a:moveTo>
                  <a:pt x="1219" y="141"/>
                </a:moveTo>
                <a:lnTo>
                  <a:pt x="1258333" y="141"/>
                </a:lnTo>
                <a:lnTo>
                  <a:pt x="1258333" y="1004264"/>
                </a:lnTo>
                <a:lnTo>
                  <a:pt x="1219" y="1004264"/>
                </a:lnTo>
                <a:close/>
              </a:path>
            </a:pathLst>
          </a:custGeom>
        </p:spPr>
      </p:pic>
      <p:pic>
        <p:nvPicPr>
          <p:cNvPr id="61" name="图片 60">
            <a:extLst>
              <a:ext uri="{FF2B5EF4-FFF2-40B4-BE49-F238E27FC236}">
                <a16:creationId xmlns:a16="http://schemas.microsoft.com/office/drawing/2014/main" id="{181631C4-D302-88F8-C0BE-F8B638744B21}"/>
              </a:ext>
            </a:extLst>
          </p:cNvPr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4732956" y="3583903"/>
            <a:ext cx="1257113" cy="1004122"/>
          </a:xfrm>
          <a:custGeom>
            <a:avLst/>
            <a:gdLst>
              <a:gd name="connsiteX0" fmla="*/ 1219 w 1257113"/>
              <a:gd name="connsiteY0" fmla="*/ -138 h 1004122"/>
              <a:gd name="connsiteX1" fmla="*/ 1258333 w 1257113"/>
              <a:gd name="connsiteY1" fmla="*/ -138 h 1004122"/>
              <a:gd name="connsiteX2" fmla="*/ 1258333 w 1257113"/>
              <a:gd name="connsiteY2" fmla="*/ 1003985 h 1004122"/>
              <a:gd name="connsiteX3" fmla="*/ 1219 w 1257113"/>
              <a:gd name="connsiteY3" fmla="*/ 1003985 h 100412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257113" h="1004122">
                <a:moveTo>
                  <a:pt x="1219" y="-138"/>
                </a:moveTo>
                <a:lnTo>
                  <a:pt x="1258333" y="-138"/>
                </a:lnTo>
                <a:lnTo>
                  <a:pt x="1258333" y="1003985"/>
                </a:lnTo>
                <a:lnTo>
                  <a:pt x="1219" y="1003985"/>
                </a:lnTo>
                <a:close/>
              </a:path>
            </a:pathLst>
          </a:custGeom>
        </p:spPr>
      </p:pic>
      <p:sp>
        <p:nvSpPr>
          <p:cNvPr id="44" name="文本框 43">
            <a:extLst>
              <a:ext uri="{FF2B5EF4-FFF2-40B4-BE49-F238E27FC236}">
                <a16:creationId xmlns:a16="http://schemas.microsoft.com/office/drawing/2014/main" id="{F1A299DE-0BFE-1958-53D6-06E835751177}"/>
              </a:ext>
            </a:extLst>
          </p:cNvPr>
          <p:cNvSpPr txBox="1"/>
          <p:nvPr/>
        </p:nvSpPr>
        <p:spPr>
          <a:xfrm>
            <a:off x="2490234" y="3287621"/>
            <a:ext cx="7481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4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文本框 45">
            <a:extLst>
              <a:ext uri="{FF2B5EF4-FFF2-40B4-BE49-F238E27FC236}">
                <a16:creationId xmlns:a16="http://schemas.microsoft.com/office/drawing/2014/main" id="{564BF64B-5ECC-7074-EE28-D89EBC22F49E}"/>
              </a:ext>
            </a:extLst>
          </p:cNvPr>
          <p:cNvSpPr txBox="1"/>
          <p:nvPr/>
        </p:nvSpPr>
        <p:spPr>
          <a:xfrm>
            <a:off x="3695981" y="3291071"/>
            <a:ext cx="7481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68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文本框 46">
            <a:extLst>
              <a:ext uri="{FF2B5EF4-FFF2-40B4-BE49-F238E27FC236}">
                <a16:creationId xmlns:a16="http://schemas.microsoft.com/office/drawing/2014/main" id="{DECEFE76-E721-09B0-B67A-0C2761FD0B5D}"/>
              </a:ext>
            </a:extLst>
          </p:cNvPr>
          <p:cNvSpPr txBox="1"/>
          <p:nvPr/>
        </p:nvSpPr>
        <p:spPr>
          <a:xfrm>
            <a:off x="5160156" y="3283381"/>
            <a:ext cx="7129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D-1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文本框 47">
            <a:extLst>
              <a:ext uri="{FF2B5EF4-FFF2-40B4-BE49-F238E27FC236}">
                <a16:creationId xmlns:a16="http://schemas.microsoft.com/office/drawing/2014/main" id="{789CFF55-47C3-2B49-867B-83083A01182A}"/>
              </a:ext>
            </a:extLst>
          </p:cNvPr>
          <p:cNvSpPr txBox="1"/>
          <p:nvPr/>
        </p:nvSpPr>
        <p:spPr>
          <a:xfrm>
            <a:off x="1193781" y="3295310"/>
            <a:ext cx="7481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3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文本框 48">
            <a:extLst>
              <a:ext uri="{FF2B5EF4-FFF2-40B4-BE49-F238E27FC236}">
                <a16:creationId xmlns:a16="http://schemas.microsoft.com/office/drawing/2014/main" id="{D0EB0627-C64B-60C4-5FA4-9FA781F7088B}"/>
              </a:ext>
            </a:extLst>
          </p:cNvPr>
          <p:cNvSpPr txBox="1"/>
          <p:nvPr/>
        </p:nvSpPr>
        <p:spPr>
          <a:xfrm rot="16200000">
            <a:off x="-249705" y="3594283"/>
            <a:ext cx="16746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e-treatment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文本框 49">
            <a:extLst>
              <a:ext uri="{FF2B5EF4-FFF2-40B4-BE49-F238E27FC236}">
                <a16:creationId xmlns:a16="http://schemas.microsoft.com/office/drawing/2014/main" id="{37CFDBED-B214-D889-EE15-FF891669C4BF}"/>
              </a:ext>
            </a:extLst>
          </p:cNvPr>
          <p:cNvSpPr txBox="1"/>
          <p:nvPr/>
        </p:nvSpPr>
        <p:spPr>
          <a:xfrm rot="16200000">
            <a:off x="-276545" y="4672180"/>
            <a:ext cx="171432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ost-treatment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2" name="图片 61">
            <a:extLst>
              <a:ext uri="{FF2B5EF4-FFF2-40B4-BE49-F238E27FC236}">
                <a16:creationId xmlns:a16="http://schemas.microsoft.com/office/drawing/2014/main" id="{173383E4-681D-E414-742D-233D793A90B2}"/>
              </a:ext>
            </a:extLst>
          </p:cNvPr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809573" y="6759578"/>
            <a:ext cx="1283456" cy="1030678"/>
          </a:xfrm>
          <a:custGeom>
            <a:avLst/>
            <a:gdLst>
              <a:gd name="connsiteX0" fmla="*/ -183 w 2096584"/>
              <a:gd name="connsiteY0" fmla="*/ -147 h 1683663"/>
              <a:gd name="connsiteX1" fmla="*/ 2096402 w 2096584"/>
              <a:gd name="connsiteY1" fmla="*/ -147 h 1683663"/>
              <a:gd name="connsiteX2" fmla="*/ 2096402 w 2096584"/>
              <a:gd name="connsiteY2" fmla="*/ 1683517 h 1683663"/>
              <a:gd name="connsiteX3" fmla="*/ -183 w 2096584"/>
              <a:gd name="connsiteY3" fmla="*/ 1683517 h 168366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2096584" h="1683663">
                <a:moveTo>
                  <a:pt x="-183" y="-147"/>
                </a:moveTo>
                <a:lnTo>
                  <a:pt x="2096402" y="-147"/>
                </a:lnTo>
                <a:lnTo>
                  <a:pt x="2096402" y="1683517"/>
                </a:lnTo>
                <a:lnTo>
                  <a:pt x="-183" y="1683517"/>
                </a:lnTo>
                <a:close/>
              </a:path>
            </a:pathLst>
          </a:custGeom>
        </p:spPr>
      </p:pic>
      <p:pic>
        <p:nvPicPr>
          <p:cNvPr id="63" name="图片 62">
            <a:extLst>
              <a:ext uri="{FF2B5EF4-FFF2-40B4-BE49-F238E27FC236}">
                <a16:creationId xmlns:a16="http://schemas.microsoft.com/office/drawing/2014/main" id="{B36087EB-96BF-72B9-3A12-B971A556907A}"/>
              </a:ext>
            </a:extLst>
          </p:cNvPr>
          <p:cNvPicPr>
            <a:picLocks noChangeAspect="1"/>
          </p:cNvPicPr>
          <p:nvPr/>
        </p:nvPicPr>
        <p:blipFill>
          <a:blip r:embed="rId21"/>
          <a:stretch>
            <a:fillRect/>
          </a:stretch>
        </p:blipFill>
        <p:spPr>
          <a:xfrm>
            <a:off x="803462" y="7832053"/>
            <a:ext cx="1279344" cy="1023394"/>
          </a:xfrm>
          <a:custGeom>
            <a:avLst/>
            <a:gdLst>
              <a:gd name="connsiteX0" fmla="*/ -182 w 2096589"/>
              <a:gd name="connsiteY0" fmla="*/ 125 h 1677137"/>
              <a:gd name="connsiteX1" fmla="*/ 2096407 w 2096589"/>
              <a:gd name="connsiteY1" fmla="*/ 125 h 1677137"/>
              <a:gd name="connsiteX2" fmla="*/ 2096407 w 2096589"/>
              <a:gd name="connsiteY2" fmla="*/ 1677263 h 1677137"/>
              <a:gd name="connsiteX3" fmla="*/ -182 w 2096589"/>
              <a:gd name="connsiteY3" fmla="*/ 1677263 h 167713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2096589" h="1677137">
                <a:moveTo>
                  <a:pt x="-182" y="125"/>
                </a:moveTo>
                <a:lnTo>
                  <a:pt x="2096407" y="125"/>
                </a:lnTo>
                <a:lnTo>
                  <a:pt x="2096407" y="1677263"/>
                </a:lnTo>
                <a:lnTo>
                  <a:pt x="-182" y="1677263"/>
                </a:lnTo>
                <a:close/>
              </a:path>
            </a:pathLst>
          </a:custGeom>
        </p:spPr>
      </p:pic>
      <p:pic>
        <p:nvPicPr>
          <p:cNvPr id="64" name="图片 63">
            <a:extLst>
              <a:ext uri="{FF2B5EF4-FFF2-40B4-BE49-F238E27FC236}">
                <a16:creationId xmlns:a16="http://schemas.microsoft.com/office/drawing/2014/main" id="{C5CF5B81-B889-AEE1-ED85-4F2684CD367C}"/>
              </a:ext>
            </a:extLst>
          </p:cNvPr>
          <p:cNvPicPr>
            <a:picLocks noChangeAspect="1"/>
          </p:cNvPicPr>
          <p:nvPr/>
        </p:nvPicPr>
        <p:blipFill>
          <a:blip r:embed="rId22"/>
          <a:stretch>
            <a:fillRect/>
          </a:stretch>
        </p:blipFill>
        <p:spPr>
          <a:xfrm>
            <a:off x="4749797" y="7832053"/>
            <a:ext cx="1296573" cy="1002208"/>
          </a:xfrm>
          <a:custGeom>
            <a:avLst/>
            <a:gdLst>
              <a:gd name="connsiteX0" fmla="*/ 1176 w 2096584"/>
              <a:gd name="connsiteY0" fmla="*/ 129 h 1683663"/>
              <a:gd name="connsiteX1" fmla="*/ 2097761 w 2096584"/>
              <a:gd name="connsiteY1" fmla="*/ 129 h 1683663"/>
              <a:gd name="connsiteX2" fmla="*/ 2097761 w 2096584"/>
              <a:gd name="connsiteY2" fmla="*/ 1683793 h 1683663"/>
              <a:gd name="connsiteX3" fmla="*/ 1176 w 2096584"/>
              <a:gd name="connsiteY3" fmla="*/ 1683793 h 168366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2096584" h="1683663">
                <a:moveTo>
                  <a:pt x="1176" y="129"/>
                </a:moveTo>
                <a:lnTo>
                  <a:pt x="2097761" y="129"/>
                </a:lnTo>
                <a:lnTo>
                  <a:pt x="2097761" y="1683793"/>
                </a:lnTo>
                <a:lnTo>
                  <a:pt x="1176" y="1683793"/>
                </a:lnTo>
                <a:close/>
              </a:path>
            </a:pathLst>
          </a:custGeom>
        </p:spPr>
      </p:pic>
      <p:pic>
        <p:nvPicPr>
          <p:cNvPr id="65" name="图片 64">
            <a:extLst>
              <a:ext uri="{FF2B5EF4-FFF2-40B4-BE49-F238E27FC236}">
                <a16:creationId xmlns:a16="http://schemas.microsoft.com/office/drawing/2014/main" id="{A58B46DC-9CC8-120E-F6B0-3C5806E37276}"/>
              </a:ext>
            </a:extLst>
          </p:cNvPr>
          <p:cNvPicPr>
            <a:picLocks noChangeAspect="1"/>
          </p:cNvPicPr>
          <p:nvPr/>
        </p:nvPicPr>
        <p:blipFill>
          <a:blip r:embed="rId23"/>
          <a:stretch>
            <a:fillRect/>
          </a:stretch>
        </p:blipFill>
        <p:spPr>
          <a:xfrm>
            <a:off x="4747742" y="6766913"/>
            <a:ext cx="1300685" cy="1011217"/>
          </a:xfrm>
          <a:custGeom>
            <a:avLst/>
            <a:gdLst>
              <a:gd name="connsiteX0" fmla="*/ 1181 w 2148837"/>
              <a:gd name="connsiteY0" fmla="*/ -144 h 1722818"/>
              <a:gd name="connsiteX1" fmla="*/ 2150019 w 2148837"/>
              <a:gd name="connsiteY1" fmla="*/ -144 h 1722818"/>
              <a:gd name="connsiteX2" fmla="*/ 2150019 w 2148837"/>
              <a:gd name="connsiteY2" fmla="*/ 1722674 h 1722818"/>
              <a:gd name="connsiteX3" fmla="*/ 1181 w 2148837"/>
              <a:gd name="connsiteY3" fmla="*/ 1722674 h 17228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2148837" h="1722818">
                <a:moveTo>
                  <a:pt x="1181" y="-144"/>
                </a:moveTo>
                <a:lnTo>
                  <a:pt x="2150019" y="-144"/>
                </a:lnTo>
                <a:lnTo>
                  <a:pt x="2150019" y="1722674"/>
                </a:lnTo>
                <a:lnTo>
                  <a:pt x="1181" y="1722674"/>
                </a:lnTo>
                <a:close/>
              </a:path>
            </a:pathLst>
          </a:custGeom>
        </p:spPr>
      </p:pic>
      <p:pic>
        <p:nvPicPr>
          <p:cNvPr id="71" name="图片 70">
            <a:extLst>
              <a:ext uri="{FF2B5EF4-FFF2-40B4-BE49-F238E27FC236}">
                <a16:creationId xmlns:a16="http://schemas.microsoft.com/office/drawing/2014/main" id="{813BDBBC-C6B9-DDA4-01FA-16AB0B25F805}"/>
              </a:ext>
            </a:extLst>
          </p:cNvPr>
          <p:cNvPicPr>
            <a:picLocks noChangeAspect="1"/>
          </p:cNvPicPr>
          <p:nvPr/>
        </p:nvPicPr>
        <p:blipFill>
          <a:blip r:embed="rId24"/>
          <a:stretch>
            <a:fillRect/>
          </a:stretch>
        </p:blipFill>
        <p:spPr>
          <a:xfrm>
            <a:off x="2129360" y="7832053"/>
            <a:ext cx="1262869" cy="1030152"/>
          </a:xfrm>
          <a:custGeom>
            <a:avLst/>
            <a:gdLst>
              <a:gd name="connsiteX0" fmla="*/ 486 w 2096589"/>
              <a:gd name="connsiteY0" fmla="*/ 128 h 1677137"/>
              <a:gd name="connsiteX1" fmla="*/ 2097075 w 2096589"/>
              <a:gd name="connsiteY1" fmla="*/ 128 h 1677137"/>
              <a:gd name="connsiteX2" fmla="*/ 2097075 w 2096589"/>
              <a:gd name="connsiteY2" fmla="*/ 1677266 h 1677137"/>
              <a:gd name="connsiteX3" fmla="*/ 486 w 2096589"/>
              <a:gd name="connsiteY3" fmla="*/ 1677266 h 167713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2096589" h="1677137">
                <a:moveTo>
                  <a:pt x="486" y="128"/>
                </a:moveTo>
                <a:lnTo>
                  <a:pt x="2097075" y="128"/>
                </a:lnTo>
                <a:lnTo>
                  <a:pt x="2097075" y="1677266"/>
                </a:lnTo>
                <a:lnTo>
                  <a:pt x="486" y="1677266"/>
                </a:lnTo>
                <a:close/>
              </a:path>
            </a:pathLst>
          </a:custGeom>
        </p:spPr>
      </p:pic>
      <p:pic>
        <p:nvPicPr>
          <p:cNvPr id="72" name="图片 71">
            <a:extLst>
              <a:ext uri="{FF2B5EF4-FFF2-40B4-BE49-F238E27FC236}">
                <a16:creationId xmlns:a16="http://schemas.microsoft.com/office/drawing/2014/main" id="{D9579792-8536-93F0-F733-B08FF21BBA9B}"/>
              </a:ext>
            </a:extLst>
          </p:cNvPr>
          <p:cNvPicPr>
            <a:picLocks noChangeAspect="1"/>
          </p:cNvPicPr>
          <p:nvPr/>
        </p:nvPicPr>
        <p:blipFill>
          <a:blip r:embed="rId25"/>
          <a:stretch>
            <a:fillRect/>
          </a:stretch>
        </p:blipFill>
        <p:spPr>
          <a:xfrm>
            <a:off x="2124981" y="6762087"/>
            <a:ext cx="1264637" cy="1035613"/>
          </a:xfrm>
          <a:custGeom>
            <a:avLst/>
            <a:gdLst>
              <a:gd name="connsiteX0" fmla="*/ 485 w 2096584"/>
              <a:gd name="connsiteY0" fmla="*/ -147 h 1683663"/>
              <a:gd name="connsiteX1" fmla="*/ 2097070 w 2096584"/>
              <a:gd name="connsiteY1" fmla="*/ -147 h 1683663"/>
              <a:gd name="connsiteX2" fmla="*/ 2097070 w 2096584"/>
              <a:gd name="connsiteY2" fmla="*/ 1683517 h 1683663"/>
              <a:gd name="connsiteX3" fmla="*/ 485 w 2096584"/>
              <a:gd name="connsiteY3" fmla="*/ 1683517 h 168366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2096584" h="1683663">
                <a:moveTo>
                  <a:pt x="485" y="-147"/>
                </a:moveTo>
                <a:lnTo>
                  <a:pt x="2097070" y="-147"/>
                </a:lnTo>
                <a:lnTo>
                  <a:pt x="2097070" y="1683517"/>
                </a:lnTo>
                <a:lnTo>
                  <a:pt x="485" y="1683517"/>
                </a:lnTo>
                <a:close/>
              </a:path>
            </a:pathLst>
          </a:custGeom>
        </p:spPr>
      </p:pic>
      <p:pic>
        <p:nvPicPr>
          <p:cNvPr id="73" name="图片 72">
            <a:extLst>
              <a:ext uri="{FF2B5EF4-FFF2-40B4-BE49-F238E27FC236}">
                <a16:creationId xmlns:a16="http://schemas.microsoft.com/office/drawing/2014/main" id="{7C31C8AF-D250-B3C4-EEFE-DA1148D49563}"/>
              </a:ext>
            </a:extLst>
          </p:cNvPr>
          <p:cNvPicPr>
            <a:picLocks noChangeAspect="1"/>
          </p:cNvPicPr>
          <p:nvPr/>
        </p:nvPicPr>
        <p:blipFill>
          <a:blip r:embed="rId26"/>
          <a:stretch>
            <a:fillRect/>
          </a:stretch>
        </p:blipFill>
        <p:spPr>
          <a:xfrm>
            <a:off x="3443162" y="6760851"/>
            <a:ext cx="1265633" cy="1023342"/>
          </a:xfrm>
          <a:custGeom>
            <a:avLst/>
            <a:gdLst>
              <a:gd name="connsiteX0" fmla="*/ 838 w 2090059"/>
              <a:gd name="connsiteY0" fmla="*/ -148 h 1670613"/>
              <a:gd name="connsiteX1" fmla="*/ 2090898 w 2090059"/>
              <a:gd name="connsiteY1" fmla="*/ -148 h 1670613"/>
              <a:gd name="connsiteX2" fmla="*/ 2090898 w 2090059"/>
              <a:gd name="connsiteY2" fmla="*/ 1670466 h 1670613"/>
              <a:gd name="connsiteX3" fmla="*/ 838 w 2090059"/>
              <a:gd name="connsiteY3" fmla="*/ 1670466 h 167061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2090059" h="1670613">
                <a:moveTo>
                  <a:pt x="838" y="-148"/>
                </a:moveTo>
                <a:lnTo>
                  <a:pt x="2090898" y="-148"/>
                </a:lnTo>
                <a:lnTo>
                  <a:pt x="2090898" y="1670466"/>
                </a:lnTo>
                <a:lnTo>
                  <a:pt x="838" y="1670466"/>
                </a:lnTo>
                <a:close/>
              </a:path>
            </a:pathLst>
          </a:custGeom>
        </p:spPr>
      </p:pic>
      <p:pic>
        <p:nvPicPr>
          <p:cNvPr id="74" name="图片 73">
            <a:extLst>
              <a:ext uri="{FF2B5EF4-FFF2-40B4-BE49-F238E27FC236}">
                <a16:creationId xmlns:a16="http://schemas.microsoft.com/office/drawing/2014/main" id="{3A93658A-7B5A-85D3-D4E6-0D23E4876E93}"/>
              </a:ext>
            </a:extLst>
          </p:cNvPr>
          <p:cNvPicPr>
            <a:picLocks noChangeAspect="1"/>
          </p:cNvPicPr>
          <p:nvPr/>
        </p:nvPicPr>
        <p:blipFill>
          <a:blip r:embed="rId27"/>
          <a:stretch>
            <a:fillRect/>
          </a:stretch>
        </p:blipFill>
        <p:spPr>
          <a:xfrm>
            <a:off x="3445541" y="7832363"/>
            <a:ext cx="1260873" cy="1012544"/>
          </a:xfrm>
          <a:custGeom>
            <a:avLst/>
            <a:gdLst>
              <a:gd name="connsiteX0" fmla="*/ 838 w 2096584"/>
              <a:gd name="connsiteY0" fmla="*/ 125 h 1683663"/>
              <a:gd name="connsiteX1" fmla="*/ 2097423 w 2096584"/>
              <a:gd name="connsiteY1" fmla="*/ 125 h 1683663"/>
              <a:gd name="connsiteX2" fmla="*/ 2097423 w 2096584"/>
              <a:gd name="connsiteY2" fmla="*/ 1683789 h 1683663"/>
              <a:gd name="connsiteX3" fmla="*/ 838 w 2096584"/>
              <a:gd name="connsiteY3" fmla="*/ 1683789 h 168366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2096584" h="1683663">
                <a:moveTo>
                  <a:pt x="838" y="125"/>
                </a:moveTo>
                <a:lnTo>
                  <a:pt x="2097423" y="125"/>
                </a:lnTo>
                <a:lnTo>
                  <a:pt x="2097423" y="1683789"/>
                </a:lnTo>
                <a:lnTo>
                  <a:pt x="838" y="1683789"/>
                </a:lnTo>
                <a:close/>
              </a:path>
            </a:pathLst>
          </a:custGeom>
        </p:spPr>
      </p:pic>
      <p:sp>
        <p:nvSpPr>
          <p:cNvPr id="75" name="文本框 74">
            <a:extLst>
              <a:ext uri="{FF2B5EF4-FFF2-40B4-BE49-F238E27FC236}">
                <a16:creationId xmlns:a16="http://schemas.microsoft.com/office/drawing/2014/main" id="{76A71BE3-1F9C-E7F8-B06B-4D14530681CC}"/>
              </a:ext>
            </a:extLst>
          </p:cNvPr>
          <p:cNvSpPr txBox="1"/>
          <p:nvPr/>
        </p:nvSpPr>
        <p:spPr>
          <a:xfrm>
            <a:off x="2490233" y="6464054"/>
            <a:ext cx="7481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8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6" name="文本框 75">
            <a:extLst>
              <a:ext uri="{FF2B5EF4-FFF2-40B4-BE49-F238E27FC236}">
                <a16:creationId xmlns:a16="http://schemas.microsoft.com/office/drawing/2014/main" id="{597BFB8E-948C-8664-DA05-18BE0808BEA0}"/>
              </a:ext>
            </a:extLst>
          </p:cNvPr>
          <p:cNvSpPr txBox="1"/>
          <p:nvPr/>
        </p:nvSpPr>
        <p:spPr>
          <a:xfrm>
            <a:off x="3740592" y="6460444"/>
            <a:ext cx="7481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68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7" name="文本框 76">
            <a:extLst>
              <a:ext uri="{FF2B5EF4-FFF2-40B4-BE49-F238E27FC236}">
                <a16:creationId xmlns:a16="http://schemas.microsoft.com/office/drawing/2014/main" id="{0B4F19F6-F4DC-6FE0-2C39-7A2F9AFB2C3F}"/>
              </a:ext>
            </a:extLst>
          </p:cNvPr>
          <p:cNvSpPr txBox="1"/>
          <p:nvPr/>
        </p:nvSpPr>
        <p:spPr>
          <a:xfrm>
            <a:off x="5160156" y="6457666"/>
            <a:ext cx="7129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D-1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8" name="文本框 77">
            <a:extLst>
              <a:ext uri="{FF2B5EF4-FFF2-40B4-BE49-F238E27FC236}">
                <a16:creationId xmlns:a16="http://schemas.microsoft.com/office/drawing/2014/main" id="{73C5FF85-0AE7-90C3-D4FB-385CB30821F9}"/>
              </a:ext>
            </a:extLst>
          </p:cNvPr>
          <p:cNvSpPr txBox="1"/>
          <p:nvPr/>
        </p:nvSpPr>
        <p:spPr>
          <a:xfrm>
            <a:off x="1193780" y="6472949"/>
            <a:ext cx="7481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3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9" name="文本框 78">
            <a:extLst>
              <a:ext uri="{FF2B5EF4-FFF2-40B4-BE49-F238E27FC236}">
                <a16:creationId xmlns:a16="http://schemas.microsoft.com/office/drawing/2014/main" id="{081DAC4F-B0DF-3379-4402-D6C84E53F460}"/>
              </a:ext>
            </a:extLst>
          </p:cNvPr>
          <p:cNvSpPr txBox="1"/>
          <p:nvPr/>
        </p:nvSpPr>
        <p:spPr>
          <a:xfrm rot="16200000">
            <a:off x="-247783" y="6770626"/>
            <a:ext cx="16746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e-treatment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0" name="文本框 79">
            <a:extLst>
              <a:ext uri="{FF2B5EF4-FFF2-40B4-BE49-F238E27FC236}">
                <a16:creationId xmlns:a16="http://schemas.microsoft.com/office/drawing/2014/main" id="{79A88828-A83D-8AA7-4D8C-0ED3858AB044}"/>
              </a:ext>
            </a:extLst>
          </p:cNvPr>
          <p:cNvSpPr txBox="1"/>
          <p:nvPr/>
        </p:nvSpPr>
        <p:spPr>
          <a:xfrm rot="16200000">
            <a:off x="-252231" y="7849244"/>
            <a:ext cx="171432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ost-treatment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9" name="文本框 88">
            <a:extLst>
              <a:ext uri="{FF2B5EF4-FFF2-40B4-BE49-F238E27FC236}">
                <a16:creationId xmlns:a16="http://schemas.microsoft.com/office/drawing/2014/main" id="{B45EADB2-9241-47E6-DBC7-6F7E81F42817}"/>
              </a:ext>
            </a:extLst>
          </p:cNvPr>
          <p:cNvSpPr txBox="1"/>
          <p:nvPr/>
        </p:nvSpPr>
        <p:spPr>
          <a:xfrm>
            <a:off x="571755" y="3015551"/>
            <a:ext cx="120244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tient 17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0" name="文本框 89">
            <a:extLst>
              <a:ext uri="{FF2B5EF4-FFF2-40B4-BE49-F238E27FC236}">
                <a16:creationId xmlns:a16="http://schemas.microsoft.com/office/drawing/2014/main" id="{C7BECF61-D0AF-53C7-4EC7-5530CF7AA9FB}"/>
              </a:ext>
            </a:extLst>
          </p:cNvPr>
          <p:cNvSpPr txBox="1"/>
          <p:nvPr/>
        </p:nvSpPr>
        <p:spPr>
          <a:xfrm>
            <a:off x="592555" y="6165172"/>
            <a:ext cx="120244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tient 24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1" name="文本框 90">
            <a:extLst>
              <a:ext uri="{FF2B5EF4-FFF2-40B4-BE49-F238E27FC236}">
                <a16:creationId xmlns:a16="http://schemas.microsoft.com/office/drawing/2014/main" id="{FF587B00-2E53-5C8B-7104-7CCFD96C9A6A}"/>
              </a:ext>
            </a:extLst>
          </p:cNvPr>
          <p:cNvSpPr txBox="1"/>
          <p:nvPr/>
        </p:nvSpPr>
        <p:spPr>
          <a:xfrm>
            <a:off x="449122" y="121801"/>
            <a:ext cx="120244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tient 18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5788832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8506</TotalTime>
  <Words>25</Words>
  <Application>Microsoft Office PowerPoint</Application>
  <PresentationFormat>A4 纸张(210x297 毫米)</PresentationFormat>
  <Paragraphs>22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等线</vt:lpstr>
      <vt:lpstr>Arial</vt:lpstr>
      <vt:lpstr>Calibri</vt:lpstr>
      <vt:lpstr>Calibri Light</vt:lpstr>
      <vt:lpstr>Times New Roman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亚丽 王</dc:creator>
  <cp:lastModifiedBy>亚丽 王</cp:lastModifiedBy>
  <cp:revision>5</cp:revision>
  <dcterms:created xsi:type="dcterms:W3CDTF">2025-05-20T15:40:38Z</dcterms:created>
  <dcterms:modified xsi:type="dcterms:W3CDTF">2025-11-08T14:02:49Z</dcterms:modified>
</cp:coreProperties>
</file>